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4" r:id="rId2"/>
  </p:sldIdLst>
  <p:sldSz cx="6858000" cy="9144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441" autoAdjust="0"/>
    <p:restoredTop sz="92462" autoAdjust="0"/>
  </p:normalViewPr>
  <p:slideViewPr>
    <p:cSldViewPr>
      <p:cViewPr>
        <p:scale>
          <a:sx n="100" d="100"/>
          <a:sy n="100" d="100"/>
        </p:scale>
        <p:origin x="-2808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46085125" cy="4608512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h7fs01.user.ki.se\Common$\Endokrinologi\Pathway%2027\ELISA%20(adipokine%20secretion)\IL-6\13-11-21%20139%20ELISA%20IL-6%20Plate%201%20and%202%20plus%20suppl%20fig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\\h7fs01.user.ki.se\Common$\Endokrinologi\Pathway%2027\LDH%20(cytotoxicity)\13-11-19%20136%20and%20137%20LDH%20Plate%203%20plus%20figure%20suppl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sv-SE"/>
  <c:chart>
    <c:autoTitleDeleted val="1"/>
    <c:plotArea>
      <c:layout>
        <c:manualLayout>
          <c:layoutTarget val="inner"/>
          <c:xMode val="edge"/>
          <c:yMode val="edge"/>
          <c:x val="0.12867418300653588"/>
          <c:y val="6.4675925925925956E-2"/>
          <c:w val="0.87132581699346445"/>
          <c:h val="0.64089074074074071"/>
        </c:manualLayout>
      </c:layout>
      <c:barChart>
        <c:barDir val="col"/>
        <c:grouping val="clustered"/>
        <c:ser>
          <c:idx val="1"/>
          <c:order val="0"/>
          <c:spPr>
            <a:solidFill>
              <a:schemeClr val="tx1"/>
            </a:solidFill>
          </c:spPr>
          <c:errBars>
            <c:errBarType val="plus"/>
            <c:errValType val="cust"/>
            <c:plus>
              <c:numRef>
                <c:f>'For publication'!$N$127:$U$127</c:f>
                <c:numCache>
                  <c:formatCode>General</c:formatCode>
                  <c:ptCount val="8"/>
                  <c:pt idx="0">
                    <c:v>0.13808103110854916</c:v>
                  </c:pt>
                  <c:pt idx="1">
                    <c:v>7.1769430605205214E-2</c:v>
                  </c:pt>
                  <c:pt idx="2">
                    <c:v>0.43702077765503289</c:v>
                  </c:pt>
                  <c:pt idx="3">
                    <c:v>0.49966015603873659</c:v>
                  </c:pt>
                  <c:pt idx="4">
                    <c:v>1.9669060076872829</c:v>
                  </c:pt>
                  <c:pt idx="5">
                    <c:v>3.9654412505935608</c:v>
                  </c:pt>
                  <c:pt idx="6">
                    <c:v>1.5450610408074934</c:v>
                  </c:pt>
                  <c:pt idx="7">
                    <c:v>0.362918114354207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For publication'!$N$114:$T$115</c:f>
              <c:multiLvlStrCache>
                <c:ptCount val="7"/>
                <c:lvl>
                  <c:pt idx="0">
                    <c:v>Control</c:v>
                  </c:pt>
                  <c:pt idx="1">
                    <c:v>0.5 µM</c:v>
                  </c:pt>
                  <c:pt idx="2">
                    <c:v>5 µM</c:v>
                  </c:pt>
                  <c:pt idx="3">
                    <c:v>10 µM</c:v>
                  </c:pt>
                  <c:pt idx="4">
                    <c:v>20 µM</c:v>
                  </c:pt>
                  <c:pt idx="5">
                    <c:v>30 µM</c:v>
                  </c:pt>
                  <c:pt idx="6">
                    <c:v>60 µM</c:v>
                  </c:pt>
                </c:lvl>
                <c:lvl>
                  <c:pt idx="1">
                    <c:v>DHA</c:v>
                  </c:pt>
                  <c:pt idx="2">
                    <c:v>DHA</c:v>
                  </c:pt>
                  <c:pt idx="3">
                    <c:v>DHA</c:v>
                  </c:pt>
                  <c:pt idx="4">
                    <c:v>DHA</c:v>
                  </c:pt>
                  <c:pt idx="5">
                    <c:v>DHA</c:v>
                  </c:pt>
                  <c:pt idx="6">
                    <c:v>DHA</c:v>
                  </c:pt>
                </c:lvl>
              </c:multiLvlStrCache>
            </c:multiLvlStrRef>
          </c:cat>
          <c:val>
            <c:numRef>
              <c:f>'For publication'!$N$126:$T$126</c:f>
              <c:numCache>
                <c:formatCode>General</c:formatCode>
                <c:ptCount val="7"/>
                <c:pt idx="0">
                  <c:v>1</c:v>
                </c:pt>
                <c:pt idx="1">
                  <c:v>0.88725593017130155</c:v>
                </c:pt>
                <c:pt idx="2">
                  <c:v>1.9230904243606102</c:v>
                </c:pt>
                <c:pt idx="3">
                  <c:v>3.3250840148666421</c:v>
                </c:pt>
                <c:pt idx="4">
                  <c:v>7.462185311801492</c:v>
                </c:pt>
                <c:pt idx="5">
                  <c:v>11.42381949009015</c:v>
                </c:pt>
                <c:pt idx="6">
                  <c:v>15.587500595134182</c:v>
                </c:pt>
              </c:numCache>
            </c:numRef>
          </c:val>
        </c:ser>
        <c:gapWidth val="80"/>
        <c:axId val="83492224"/>
        <c:axId val="82941056"/>
      </c:barChart>
      <c:catAx>
        <c:axId val="83492224"/>
        <c:scaling>
          <c:orientation val="minMax"/>
        </c:scaling>
        <c:axPos val="b"/>
        <c:tickLblPos val="nextTo"/>
        <c:txPr>
          <a:bodyPr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sv-SE"/>
          </a:p>
        </c:txPr>
        <c:crossAx val="82941056"/>
        <c:crosses val="autoZero"/>
        <c:auto val="1"/>
        <c:lblAlgn val="ctr"/>
        <c:lblOffset val="100"/>
        <c:noMultiLvlLbl val="1"/>
      </c:catAx>
      <c:valAx>
        <c:axId val="82941056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800" b="1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800" b="1"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sz="800" b="1" baseline="0">
                    <a:latin typeface="Arial" panose="020B0604020202020204" pitchFamily="34" charset="0"/>
                    <a:cs typeface="Arial" panose="020B0604020202020204" pitchFamily="34" charset="0"/>
                  </a:rPr>
                  <a:t> IL-6 secretion</a:t>
                </a:r>
                <a:endParaRPr lang="en-US" sz="8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12446064814814818"/>
            </c:manualLayout>
          </c:layout>
        </c:title>
        <c:numFmt formatCode="General" sourceLinked="1"/>
        <c:tickLblPos val="nextTo"/>
        <c:txPr>
          <a:bodyPr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sv-SE"/>
          </a:p>
        </c:txPr>
        <c:crossAx val="83492224"/>
        <c:crosses val="autoZero"/>
        <c:crossBetween val="between"/>
      </c:valAx>
    </c:plotArea>
    <c:plotVisOnly val="1"/>
    <c:dispBlanksAs val="gap"/>
  </c:chart>
  <c:spPr>
    <a:ln>
      <a:noFill/>
    </a:ln>
  </c:sp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sv-SE"/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2867418300653588"/>
          <c:y val="6.4675925925925928E-2"/>
          <c:w val="0.87132581699346445"/>
          <c:h val="0.64089074074074071"/>
        </c:manualLayout>
      </c:layout>
      <c:barChart>
        <c:barDir val="col"/>
        <c:grouping val="clustered"/>
        <c:ser>
          <c:idx val="1"/>
          <c:order val="0"/>
          <c:spPr>
            <a:solidFill>
              <a:schemeClr val="tx1"/>
            </a:solidFill>
          </c:spPr>
          <c:errBars>
            <c:errBarType val="plus"/>
            <c:errValType val="cust"/>
            <c:plus>
              <c:numRef>
                <c:f>'[13-11-19 136 and 137 LDH Plate 3 plus figure suppl.xlsx]For publication'!$B$62:$E$62</c:f>
                <c:numCache>
                  <c:formatCode>General</c:formatCode>
                  <c:ptCount val="4"/>
                  <c:pt idx="0">
                    <c:v>0.11837095526946355</c:v>
                  </c:pt>
                  <c:pt idx="1">
                    <c:v>0.22918642822674842</c:v>
                  </c:pt>
                  <c:pt idx="2">
                    <c:v>0.97683465230078748</c:v>
                  </c:pt>
                  <c:pt idx="3">
                    <c:v>0.2800805866178747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[13-11-19 136 and 137 LDH Plate 3 plus figure suppl.xlsx]For publication'!$B$34:$E$35</c:f>
              <c:multiLvlStrCache>
                <c:ptCount val="4"/>
                <c:lvl>
                  <c:pt idx="0">
                    <c:v>Control</c:v>
                  </c:pt>
                  <c:pt idx="1">
                    <c:v>0.5μM</c:v>
                  </c:pt>
                  <c:pt idx="2">
                    <c:v>10 μM</c:v>
                  </c:pt>
                  <c:pt idx="3">
                    <c:v>60 μM</c:v>
                  </c:pt>
                </c:lvl>
                <c:lvl>
                  <c:pt idx="1">
                    <c:v>DHA</c:v>
                  </c:pt>
                  <c:pt idx="2">
                    <c:v>DHA</c:v>
                  </c:pt>
                  <c:pt idx="3">
                    <c:v>DHA</c:v>
                  </c:pt>
                </c:lvl>
              </c:multiLvlStrCache>
            </c:multiLvlStrRef>
          </c:cat>
          <c:val>
            <c:numRef>
              <c:f>'[13-11-19 136 and 137 LDH Plate 3 plus figure suppl.xlsx]For publication'!$B$61:$E$61</c:f>
              <c:numCache>
                <c:formatCode>General</c:formatCode>
                <c:ptCount val="4"/>
                <c:pt idx="0">
                  <c:v>0.99999766822222236</c:v>
                </c:pt>
                <c:pt idx="1">
                  <c:v>1.0390841565624582</c:v>
                </c:pt>
                <c:pt idx="2">
                  <c:v>2.8528984173720997</c:v>
                </c:pt>
                <c:pt idx="3">
                  <c:v>4.8212982397499982</c:v>
                </c:pt>
              </c:numCache>
            </c:numRef>
          </c:val>
        </c:ser>
        <c:gapWidth val="80"/>
        <c:axId val="86914944"/>
        <c:axId val="86916480"/>
      </c:barChart>
      <c:catAx>
        <c:axId val="86914944"/>
        <c:scaling>
          <c:orientation val="minMax"/>
        </c:scaling>
        <c:axPos val="b"/>
        <c:tickLblPos val="nextTo"/>
        <c:txPr>
          <a:bodyPr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sv-SE"/>
          </a:p>
        </c:txPr>
        <c:crossAx val="86916480"/>
        <c:crosses val="autoZero"/>
        <c:auto val="1"/>
        <c:lblAlgn val="ctr"/>
        <c:lblOffset val="100"/>
        <c:noMultiLvlLbl val="1"/>
      </c:catAx>
      <c:valAx>
        <c:axId val="86916480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800" b="1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sz="800" b="1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800" b="1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DH activity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5185947712418301E-2"/>
              <c:y val="0.15973842592592599"/>
            </c:manualLayout>
          </c:layout>
        </c:title>
        <c:numFmt formatCode="General" sourceLinked="1"/>
        <c:tickLblPos val="nextTo"/>
        <c:txPr>
          <a:bodyPr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sv-SE"/>
          </a:p>
        </c:txPr>
        <c:crossAx val="86914944"/>
        <c:crosses val="autoZero"/>
        <c:crossBetween val="between"/>
      </c:valAx>
    </c:plotArea>
    <c:plotVisOnly val="1"/>
    <c:dispBlanksAs val="gap"/>
  </c:chart>
  <c:spPr>
    <a:ln>
      <a:noFill/>
    </a:ln>
  </c:spPr>
  <c:externalData r:id="rId2"/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9838F09E-6F71-4903-8F79-974843AD4203}" type="datetimeFigureOut">
              <a:rPr lang="en-GB"/>
              <a:pPr>
                <a:defRPr/>
              </a:pPr>
              <a:t>11/01/2016</a:t>
            </a:fld>
            <a:endParaRPr lang="en-GB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373E8D55-4FBB-4C93-BB28-EEFC699AA60E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25456550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F924E2A2-3A3D-487C-924F-5926C3A54E64}" type="datetimeFigureOut">
              <a:rPr lang="en-GB"/>
              <a:pPr>
                <a:defRPr/>
              </a:pPr>
              <a:t>11/01/2016</a:t>
            </a:fld>
            <a:endParaRPr lang="en-GB"/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 noProof="0" smtClean="0"/>
              <a:t>Klicka här för att ändra format på bakgrundstexten</a:t>
            </a:r>
          </a:p>
          <a:p>
            <a:pPr lvl="1"/>
            <a:r>
              <a:rPr lang="sv-SE" noProof="0" smtClean="0"/>
              <a:t>Nivå två</a:t>
            </a:r>
          </a:p>
          <a:p>
            <a:pPr lvl="2"/>
            <a:r>
              <a:rPr lang="sv-SE" noProof="0" smtClean="0"/>
              <a:t>Nivå tre</a:t>
            </a:r>
          </a:p>
          <a:p>
            <a:pPr lvl="3"/>
            <a:r>
              <a:rPr lang="sv-SE" noProof="0" smtClean="0"/>
              <a:t>Nivå fyra</a:t>
            </a:r>
          </a:p>
          <a:p>
            <a:pPr lvl="4"/>
            <a:r>
              <a:rPr lang="sv-SE" noProof="0" smtClean="0"/>
              <a:t>Nivå fem</a:t>
            </a:r>
            <a:endParaRPr lang="en-GB" noProof="0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1B0FD712-E056-479C-B687-5F50158B247B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8291070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FFB47D-6699-4374-B20D-C32FB3EF1FDB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EEE77B-A8E1-49D1-939F-4BFC4F7945D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328472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8A201B-59DA-49A6-83C7-B79321A0A7AB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7AE2C4-533A-48C1-98D8-58B57E36F1E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743146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2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2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FBC042-70B2-45AE-BD06-2090D6D12D89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9336CED-9BAD-432A-BD2E-586EE0CA53A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4600366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649EB2-F9BC-40E8-B276-092DEDC6901F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2B1DE4-FCEA-4EE4-84AB-B0FC6C95FA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781462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1E70FB-17F2-4FB0-A09D-06FF41E71A35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3E5D26-50B0-4CD5-AC15-C55387FFE5F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95604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2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4" y="2844802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B5825B-AC0F-41EA-A5B9-32C2C2007AFA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C832C1-E6C5-4714-A79D-BD20FC30914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934570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9DE8A0-91FB-431A-AD5C-755469074929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6DC068-22E1-4722-BCA3-4B105DD37A9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673889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70BAF2-ECF2-4206-AD98-C23CCE289029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331FDF-C831-40B0-B98C-B0C2A57FB4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8897909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85776E-E103-4493-9EA1-6BBA2E278F1C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093AB8-6EB4-496B-A98E-27ACE4921D2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545538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9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FAB479-DCC5-46DE-8F65-0D6DC944DD1D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5ADF7C-8E6E-4512-954A-E4C96F246C0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8474101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085C18-9133-4843-834B-51F497B1A0C6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BB35AF-2503-4977-ADF9-8C448A79173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809456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12B3C14E-EDD2-41C0-9DA1-06EB77B58C57}" type="datetimeFigureOut">
              <a:rPr lang="en-US"/>
              <a:pPr>
                <a:defRPr/>
              </a:pPr>
              <a:t>1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BF2549D4-A688-4D6C-8179-872F6D09130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Diagram 13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3768676492"/>
              </p:ext>
            </p:extLst>
          </p:nvPr>
        </p:nvGraphicFramePr>
        <p:xfrm>
          <a:off x="3453457" y="594759"/>
          <a:ext cx="30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171" name="TextBox 3"/>
          <p:cNvSpPr txBox="1">
            <a:spLocks noChangeArrowheads="1"/>
          </p:cNvSpPr>
          <p:nvPr/>
        </p:nvSpPr>
        <p:spPr bwMode="auto">
          <a:xfrm>
            <a:off x="323655" y="2726795"/>
            <a:ext cx="6390710" cy="15081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buNone/>
            </a:pP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Additional file 2: Figure S2. Adverse effects of DHA on adipocyte cytotoxicity and IL-6 secretion. </a:t>
            </a:r>
            <a:endParaRPr lang="sv-SE" sz="1000" dirty="0" smtClean="0">
              <a:latin typeface="Arial" pitchFamily="34" charset="0"/>
              <a:cs typeface="Arial" pitchFamily="34" charset="0"/>
            </a:endParaRPr>
          </a:p>
          <a:p>
            <a:pPr>
              <a:buNone/>
            </a:pPr>
            <a:r>
              <a:rPr lang="en-US" sz="1000" dirty="0" smtClean="0">
                <a:latin typeface="Arial" pitchFamily="34" charset="0"/>
                <a:cs typeface="Arial" pitchFamily="34" charset="0"/>
              </a:rPr>
              <a:t>Cytotoxicity detection measured as lactate dehydrogenase (LDH) activity in conditioned media after 6 days of treatment with 0.5 µM, 10 µM or 60 µM DHA, relative to control 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(a)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. Control, n=7; 0.5 µM DHA , n=3; 10 µM and 60 µM DHA, n=2 biological/independent experiments in at least duplicates. Secretion of IL-6 from human 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in vitro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differentiated adipocytes after 48 hours of treatment with 0.5 µM, 5 µM, 10 µM, 20 µM, 30 µM or 60 µM DHA compared to control (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b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). Control, n=2 and DHA n=1 biological/independent experiments in triplicates. Normalized data is adjusted for protein amount and presented as means +/- standard deviation. *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p&lt;0.05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, **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p&lt;0.01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and ***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p&lt;0.001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versus control. Statistical significance was obtained by one-way ANOVA with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Tukey’s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multiple comparisons post hoc test.</a:t>
            </a:r>
            <a:endParaRPr lang="sv-SE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72" name="textruta 42"/>
          <p:cNvSpPr txBox="1">
            <a:spLocks noChangeArrowheads="1"/>
          </p:cNvSpPr>
          <p:nvPr/>
        </p:nvSpPr>
        <p:spPr bwMode="auto">
          <a:xfrm>
            <a:off x="188913" y="471488"/>
            <a:ext cx="26987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>
                <a:latin typeface="Arial" charset="0"/>
              </a:rPr>
              <a:t>a</a:t>
            </a:r>
          </a:p>
        </p:txBody>
      </p:sp>
      <p:sp>
        <p:nvSpPr>
          <p:cNvPr id="7173" name="textruta 43"/>
          <p:cNvSpPr txBox="1">
            <a:spLocks noChangeArrowheads="1"/>
          </p:cNvSpPr>
          <p:nvPr/>
        </p:nvSpPr>
        <p:spPr bwMode="auto">
          <a:xfrm>
            <a:off x="3300413" y="471488"/>
            <a:ext cx="26987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>
                <a:latin typeface="Arial" charset="0"/>
              </a:rPr>
              <a:t>b</a:t>
            </a:r>
          </a:p>
        </p:txBody>
      </p:sp>
      <p:graphicFrame>
        <p:nvGraphicFramePr>
          <p:cNvPr id="8" name="Diagram 7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3261149194"/>
              </p:ext>
            </p:extLst>
          </p:nvPr>
        </p:nvGraphicFramePr>
        <p:xfrm>
          <a:off x="240413" y="594759"/>
          <a:ext cx="30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175" name="textruta 1"/>
          <p:cNvSpPr txBox="1">
            <a:spLocks noChangeArrowheads="1"/>
          </p:cNvSpPr>
          <p:nvPr/>
        </p:nvSpPr>
        <p:spPr bwMode="auto">
          <a:xfrm>
            <a:off x="2143125" y="1062038"/>
            <a:ext cx="430213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sv-SE" altLang="en-US" sz="900">
                <a:latin typeface="Arial" charset="0"/>
              </a:rPr>
              <a:t>***</a:t>
            </a:r>
          </a:p>
        </p:txBody>
      </p:sp>
      <p:sp>
        <p:nvSpPr>
          <p:cNvPr id="7176" name="textruta 1"/>
          <p:cNvSpPr txBox="1">
            <a:spLocks noChangeArrowheads="1"/>
          </p:cNvSpPr>
          <p:nvPr/>
        </p:nvSpPr>
        <p:spPr bwMode="auto">
          <a:xfrm>
            <a:off x="2814638" y="746125"/>
            <a:ext cx="388937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sv-SE" altLang="en-US" sz="900">
                <a:latin typeface="Arial" charset="0"/>
              </a:rPr>
              <a:t>***</a:t>
            </a:r>
          </a:p>
        </p:txBody>
      </p:sp>
      <p:sp>
        <p:nvSpPr>
          <p:cNvPr id="7179" name="Textfeld 1"/>
          <p:cNvSpPr txBox="1">
            <a:spLocks noChangeArrowheads="1"/>
          </p:cNvSpPr>
          <p:nvPr/>
        </p:nvSpPr>
        <p:spPr bwMode="auto">
          <a:xfrm>
            <a:off x="5376115" y="1214438"/>
            <a:ext cx="43815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en-US" sz="900" dirty="0" smtClean="0">
                <a:latin typeface="Arial" charset="0"/>
              </a:rPr>
              <a:t>***</a:t>
            </a:r>
            <a:endParaRPr lang="de-DE" altLang="en-US" sz="900" dirty="0">
              <a:latin typeface="Arial" charset="0"/>
            </a:endParaRPr>
          </a:p>
        </p:txBody>
      </p:sp>
      <p:sp>
        <p:nvSpPr>
          <p:cNvPr id="7180" name="Textfeld 1"/>
          <p:cNvSpPr txBox="1">
            <a:spLocks noChangeArrowheads="1"/>
          </p:cNvSpPr>
          <p:nvPr/>
        </p:nvSpPr>
        <p:spPr bwMode="auto">
          <a:xfrm>
            <a:off x="5769260" y="742950"/>
            <a:ext cx="43815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en-US" sz="900" dirty="0" smtClean="0">
                <a:latin typeface="Arial" charset="0"/>
              </a:rPr>
              <a:t>***</a:t>
            </a:r>
            <a:endParaRPr lang="de-DE" altLang="en-US" sz="900" dirty="0">
              <a:latin typeface="Arial" charset="0"/>
            </a:endParaRPr>
          </a:p>
        </p:txBody>
      </p:sp>
      <p:sp>
        <p:nvSpPr>
          <p:cNvPr id="7181" name="Textfeld 1"/>
          <p:cNvSpPr txBox="1">
            <a:spLocks noChangeArrowheads="1"/>
          </p:cNvSpPr>
          <p:nvPr/>
        </p:nvSpPr>
        <p:spPr bwMode="auto">
          <a:xfrm>
            <a:off x="6129338" y="623888"/>
            <a:ext cx="43815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en-US" sz="900">
                <a:latin typeface="Arial" charset="0"/>
              </a:rPr>
              <a:t>***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 bwMode="auto">
        <a:noFill/>
        <a:ln>
          <a:noFill/>
        </a:ln>
        <a:extLst>
          <a:ext uri="{909E8E84-426E-40DD-AFC4-6F175D3DCCD1}">
            <a14:hiddenFill xmlns="" xmlns:a14="http://schemas.microsoft.com/office/drawing/2010/main">
              <a:solidFill>
                <a:srgbClr val="FFFFFF"/>
              </a:solidFill>
            </a14:hiddenFill>
          </a:ext>
          <a:ext uri="{91240B29-F687-4F45-9708-019B960494DF}">
            <a14:hiddenLine xmlns="" xmlns:a14="http://schemas.microsoft.com/office/drawing/2010/main" w="9525">
              <a:solidFill>
                <a:srgbClr val="000000"/>
              </a:solidFill>
              <a:miter lim="800000"/>
              <a:headEnd/>
              <a:tailEnd/>
            </a14:hiddenLine>
          </a:ext>
        </a:extLst>
      </a:spPr>
      <a:bodyPr>
        <a:spAutoFit/>
      </a:bodyPr>
      <a:lstStyle>
        <a:defPPr eaLnBrk="1" hangingPunct="1">
          <a:spcBef>
            <a:spcPct val="0"/>
          </a:spcBef>
          <a:buFontTx/>
          <a:buNone/>
          <a:defRPr sz="900" dirty="0" smtClean="0">
            <a:latin typeface="Arial" charset="0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7143</TotalTime>
  <Words>182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Windows Use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nnie</dc:creator>
  <cp:lastModifiedBy>CM</cp:lastModifiedBy>
  <cp:revision>441</cp:revision>
  <cp:lastPrinted>2014-10-27T13:04:57Z</cp:lastPrinted>
  <dcterms:created xsi:type="dcterms:W3CDTF">2014-02-13T13:47:19Z</dcterms:created>
  <dcterms:modified xsi:type="dcterms:W3CDTF">2016-01-11T13:08:19Z</dcterms:modified>
</cp:coreProperties>
</file>